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D1E03D-D206-4031-9E9E-86BA5947AE4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0B08E0-A47B-46E3-AA50-AEB5EB9296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FA48DF-7A4D-421C-973B-D0F0E6CAEDA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0D4F5A-837C-4573-BAA0-242950FA1A3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5F4FD7-8550-42DD-B5A0-A1F4D7EDA4E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627C1D-2CB4-4C3B-9A23-50047DAD3D2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56CD8B-7E1A-462D-A0E0-FF3FFC8FD6B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B58CF2-CCD8-45AB-A944-126E1D0D8A5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BDFA4A-263D-4DC6-B1D0-B3ABE82D15F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1E99E9-215E-4754-B829-02232FB3BC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48F3F4-4653-49B8-9DB8-4755460A22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D1EC47-8B83-49AA-9A81-52237EB6F7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BF0FE3E-C5AC-451B-AF5F-E12D89925A26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266080" y="2620800"/>
            <a:ext cx="14407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.I. not implanted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.R. not recorded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2X8 arra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230040" y="911160"/>
          <a:ext cx="6480360" cy="161784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3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30040" y="911160"/>
                    <a:ext cx="6480360" cy="1617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4" name=""/>
          <p:cNvSpPr/>
          <p:nvPr/>
        </p:nvSpPr>
        <p:spPr>
          <a:xfrm>
            <a:off x="228600" y="304920"/>
            <a:ext cx="64771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) Neuronal yield: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Up to 159 neurons were recorded from 3 to 4 different brain areas, as detailed in the table below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914400" y="2651040"/>
            <a:ext cx="38098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umbers out of parenthesis: # recorded neuron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umbers inside parenthesis: # implanted wire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5353200" y="2955960"/>
            <a:ext cx="3618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7" name="" descr=""/>
          <p:cNvPicPr/>
          <p:nvPr/>
        </p:nvPicPr>
        <p:blipFill>
          <a:blip r:embed="rId3"/>
          <a:stretch/>
        </p:blipFill>
        <p:spPr>
          <a:xfrm>
            <a:off x="228600" y="3276720"/>
            <a:ext cx="6477120" cy="5395680"/>
          </a:xfrm>
          <a:prstGeom prst="rect">
            <a:avLst/>
          </a:prstGeom>
          <a:ln w="0">
            <a:noFill/>
          </a:ln>
        </p:spPr>
      </p:pic>
      <p:sp>
        <p:nvSpPr>
          <p:cNvPr id="48" name=""/>
          <p:cNvSpPr/>
          <p:nvPr/>
        </p:nvSpPr>
        <p:spPr>
          <a:xfrm>
            <a:off x="228600" y="8686800"/>
            <a:ext cx="6400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Example of neuronal firing record (partial set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3-03-27T01:46:11Z</dcterms:created>
  <dc:creator>Sidarta Ribeiro</dc:creator>
  <dc:description/>
  <dc:language>en-US</dc:language>
  <cp:lastModifiedBy>Liana Holmberg</cp:lastModifiedBy>
  <dcterms:modified xsi:type="dcterms:W3CDTF">2003-12-05T00:13:02Z</dcterms:modified>
  <cp:revision>86</cp:revision>
  <dc:subject/>
  <dc:title>Supplementary Material</dc:title>
</cp:coreProperties>
</file>